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326" r:id="rId2"/>
    <p:sldId id="265" r:id="rId3"/>
    <p:sldId id="325" r:id="rId4"/>
    <p:sldId id="316" r:id="rId5"/>
    <p:sldId id="324" r:id="rId6"/>
  </p:sldIdLst>
  <p:sldSz cx="7772400" cy="10058400"/>
  <p:notesSz cx="9236075" cy="6950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2838BEF-8BB2-4498-84A7-C5851F593DF1}" styleName="Medium Style 4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21" autoAdjust="0"/>
    <p:restoredTop sz="95226" autoAdjust="0"/>
  </p:normalViewPr>
  <p:slideViewPr>
    <p:cSldViewPr snapToGrid="0">
      <p:cViewPr varScale="1">
        <p:scale>
          <a:sx n="63" d="100"/>
          <a:sy n="63" d="100"/>
        </p:scale>
        <p:origin x="2616" y="90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6" y="0"/>
            <a:ext cx="4002299" cy="3475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31645" y="0"/>
            <a:ext cx="4002299" cy="3475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375C42C6-4A5D-44A1-B787-50584AE7E4AD}" type="datetimeFigureOut">
              <a:rPr lang="en-IN" smtClean="0"/>
              <a:t>21-09-2021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611563" y="520700"/>
            <a:ext cx="2012950" cy="2606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23608" y="3301286"/>
            <a:ext cx="7388860" cy="3127534"/>
          </a:xfrm>
          <a:prstGeom prst="rect">
            <a:avLst/>
          </a:prstGeom>
        </p:spPr>
        <p:txBody>
          <a:bodyPr vert="horz" lIns="92492" tIns="46246" rIns="92492" bIns="46246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6" y="6601365"/>
            <a:ext cx="4002299" cy="3475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31645" y="6601365"/>
            <a:ext cx="4002299" cy="3475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084B830B-7933-4278-B34B-E9E2F8C6C01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641500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1pPr>
    <a:lvl2pPr marL="457132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2pPr>
    <a:lvl3pPr marL="914263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3pPr>
    <a:lvl4pPr marL="1371395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4pPr>
    <a:lvl5pPr marL="1828527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5pPr>
    <a:lvl6pPr marL="2285658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6pPr>
    <a:lvl7pPr marL="2742790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7pPr>
    <a:lvl8pPr marL="3199920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8pPr>
    <a:lvl9pPr marL="3657052" algn="l" defTabSz="914263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611563" y="520700"/>
            <a:ext cx="2012950" cy="26066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84B830B-7933-4278-B34B-E9E2F8C6C010}" type="slidenum">
              <a:rPr lang="en-IN" smtClean="0"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822459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473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568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752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623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773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570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317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465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074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176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750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F6E4CF-2DA4-4FF5-9EAC-7E89D625C679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561A6B-80A5-44E9-B68B-E56128B629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196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05B5570C-982A-644C-8542-28CF6A3377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1740552"/>
              </p:ext>
            </p:extLst>
          </p:nvPr>
        </p:nvGraphicFramePr>
        <p:xfrm>
          <a:off x="872173" y="3082495"/>
          <a:ext cx="6305141" cy="3388995"/>
        </p:xfrm>
        <a:graphic>
          <a:graphicData uri="http://schemas.openxmlformats.org/drawingml/2006/table">
            <a:tbl>
              <a:tblPr firstRow="1" firstCol="1" bandRow="1">
                <a:tableStyleId>{5A111915-BE36-4E01-A7E5-04B1672EAD32}</a:tableStyleId>
              </a:tblPr>
              <a:tblGrid>
                <a:gridCol w="1076960">
                  <a:extLst>
                    <a:ext uri="{9D8B030D-6E8A-4147-A177-3AD203B41FA5}">
                      <a16:colId xmlns:a16="http://schemas.microsoft.com/office/drawing/2014/main" xmlns="" val="1034409814"/>
                    </a:ext>
                  </a:extLst>
                </a:gridCol>
                <a:gridCol w="2630124">
                  <a:extLst>
                    <a:ext uri="{9D8B030D-6E8A-4147-A177-3AD203B41FA5}">
                      <a16:colId xmlns:a16="http://schemas.microsoft.com/office/drawing/2014/main" xmlns="" val="2202713882"/>
                    </a:ext>
                  </a:extLst>
                </a:gridCol>
                <a:gridCol w="2598057">
                  <a:extLst>
                    <a:ext uri="{9D8B030D-6E8A-4147-A177-3AD203B41FA5}">
                      <a16:colId xmlns:a16="http://schemas.microsoft.com/office/drawing/2014/main" xmlns="" val="655381776"/>
                    </a:ext>
                  </a:extLst>
                </a:gridCol>
              </a:tblGrid>
              <a:tr h="32194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(5'-3'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(5'-3'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65552639"/>
                  </a:ext>
                </a:extLst>
              </a:tr>
              <a:tr h="30670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e-18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GCCGCCATGTCTCTAG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TCCTCAACACCACATGAGC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10739037"/>
                  </a:ext>
                </a:extLst>
              </a:tr>
              <a:tr h="30670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e-FTO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ATGCTGGATGACCTCAATG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AACTGACAGCGTTCTAAG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83078484"/>
                  </a:ext>
                </a:extLst>
              </a:tr>
              <a:tr h="30670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e-IL-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GTCCTTCCTACCCCAATTTCC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GTCCTTAGCCACTCCTTC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26366510"/>
                  </a:ext>
                </a:extLst>
              </a:tr>
              <a:tr h="30670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e-TNF-α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TCACACTCAGATCATCTTC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ACGACGTGGGCTACAG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70734473"/>
                  </a:ext>
                </a:extLst>
              </a:tr>
              <a:tr h="30670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e-IL-1β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ACTGTTCCTGAACTCAAC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TTTTGGGGTCCGTCAAC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28695886"/>
                  </a:ext>
                </a:extLst>
              </a:tr>
              <a:tr h="30670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-IL-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CTCCGCAAGAGACTTCCA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ACTGGTCTGTTGTGGGTGG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43751902"/>
                  </a:ext>
                </a:extLst>
              </a:tr>
              <a:tr h="30670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-TNF-α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GAGTGACAAGCCCGTAG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GCCTTGTCCCTTGAAGA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27036132"/>
                  </a:ext>
                </a:extLst>
              </a:tr>
              <a:tr h="30670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-FTO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GTCGAGTTTGAGTGGC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AGCACGGCATTTGTCAC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14129749"/>
                  </a:ext>
                </a:extLst>
              </a:tr>
              <a:tr h="30670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-β-Actin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TTCTGATGCTTTAGACAAGA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TGACATGCAGCAGGTT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87218420"/>
                  </a:ext>
                </a:extLst>
              </a:tr>
              <a:tr h="30670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-GAPDH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CAGCCGCATCTTCTTG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GCCGTGGGTAGAGTCA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21803932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xmlns="" id="{51C8B929-42A2-2E47-8DD0-7B002B5388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2173" y="2576896"/>
            <a:ext cx="5865516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Table S1: Primer sequences used for real-time qPCR analysis </a:t>
            </a:r>
            <a:endParaRPr kumimoji="0" lang="en-US" altLang="en-US" sz="5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32334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392B24C5-B808-4CE0-BDE5-A2E4566EF9B7}"/>
              </a:ext>
            </a:extLst>
          </p:cNvPr>
          <p:cNvGrpSpPr/>
          <p:nvPr/>
        </p:nvGrpSpPr>
        <p:grpSpPr>
          <a:xfrm>
            <a:off x="251883" y="2797009"/>
            <a:ext cx="7520517" cy="3394348"/>
            <a:chOff x="178516" y="1225443"/>
            <a:chExt cx="8653612" cy="4040532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xmlns="" id="{DFDFF3BE-C733-4038-B1F1-09F02719A01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65554301"/>
                </p:ext>
              </p:extLst>
            </p:nvPr>
          </p:nvGraphicFramePr>
          <p:xfrm>
            <a:off x="2998186" y="1875703"/>
            <a:ext cx="3014273" cy="33902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13" name="Prism 9" r:id="rId4" imgW="2212314" imgH="2495867" progId="Prism9.Document">
                    <p:embed/>
                  </p:oleObj>
                </mc:Choice>
                <mc:Fallback>
                  <p:oleObj name="Prism 9" r:id="rId4" imgW="2212314" imgH="2495867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xmlns="" id="{DFDFF3BE-C733-4038-B1F1-09F02719A01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998186" y="1875703"/>
                          <a:ext cx="3014273" cy="339027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xmlns="" id="{79A1CBB1-9284-41EB-9BD8-4CBDA16615D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57694036"/>
                </p:ext>
              </p:extLst>
            </p:nvPr>
          </p:nvGraphicFramePr>
          <p:xfrm>
            <a:off x="5917227" y="1760052"/>
            <a:ext cx="2914901" cy="340740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14" name="Prism 9" r:id="rId6" imgW="2143528" imgH="2500550" progId="Prism9.Document">
                    <p:embed/>
                  </p:oleObj>
                </mc:Choice>
                <mc:Fallback>
                  <p:oleObj name="Prism 9" r:id="rId6" imgW="2143528" imgH="2500550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xmlns="" id="{79A1CBB1-9284-41EB-9BD8-4CBDA16615D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5917227" y="1760052"/>
                          <a:ext cx="2914901" cy="340740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xmlns="" id="{14064451-20EB-464F-897F-440D96AC901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1169932"/>
                </p:ext>
              </p:extLst>
            </p:nvPr>
          </p:nvGraphicFramePr>
          <p:xfrm>
            <a:off x="178516" y="1745061"/>
            <a:ext cx="3111575" cy="345452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315" name="Prism 9" r:id="rId8" imgW="2285421" imgH="2536925" progId="Prism9.Document">
                    <p:embed/>
                  </p:oleObj>
                </mc:Choice>
                <mc:Fallback>
                  <p:oleObj name="Prism 9" r:id="rId8" imgW="2285421" imgH="2536925" progId="Prism9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xmlns="" id="{14064451-20EB-464F-897F-440D96AC901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78516" y="1745061"/>
                          <a:ext cx="3111575" cy="345452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FB3C1C26-FF88-44BE-BCBE-69615E766A18}"/>
                </a:ext>
              </a:extLst>
            </p:cNvPr>
            <p:cNvSpPr txBox="1"/>
            <p:nvPr/>
          </p:nvSpPr>
          <p:spPr>
            <a:xfrm>
              <a:off x="559769" y="1231581"/>
              <a:ext cx="409579" cy="359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6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AB84EED2-110F-48C5-BF31-6199A7C28DF3}"/>
                </a:ext>
              </a:extLst>
            </p:cNvPr>
            <p:cNvSpPr txBox="1"/>
            <p:nvPr/>
          </p:nvSpPr>
          <p:spPr>
            <a:xfrm>
              <a:off x="3188810" y="1225443"/>
              <a:ext cx="409579" cy="359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6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593CCA46-4C86-4EAF-A91C-6D51E9A10A7C}"/>
                </a:ext>
              </a:extLst>
            </p:cNvPr>
            <p:cNvSpPr txBox="1"/>
            <p:nvPr/>
          </p:nvSpPr>
          <p:spPr>
            <a:xfrm>
              <a:off x="5832348" y="1234847"/>
              <a:ext cx="304330" cy="3590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6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17E29096-3A12-4555-AC6A-8B4BED93BB20}"/>
              </a:ext>
            </a:extLst>
          </p:cNvPr>
          <p:cNvSpPr txBox="1"/>
          <p:nvPr/>
        </p:nvSpPr>
        <p:spPr>
          <a:xfrm>
            <a:off x="3135902" y="1778000"/>
            <a:ext cx="2029506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360" b="1" dirty="0"/>
              <a:t>Supplementary Fig. S1</a:t>
            </a:r>
            <a:endParaRPr lang="en-US" sz="136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36EBDFC5-76B5-C441-ABB8-6034BD07738D}"/>
              </a:ext>
            </a:extLst>
          </p:cNvPr>
          <p:cNvSpPr/>
          <p:nvPr/>
        </p:nvSpPr>
        <p:spPr>
          <a:xfrm>
            <a:off x="583215" y="6624015"/>
            <a:ext cx="656150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Figure S1. Effect of endotoxemia on cardiac dysfunction in mice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Echocardiographic quantification of (A) Heart rate (BPM), (B) LV diastolic volume and (C) Left ventricle internal diameter at diastole (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LVIDd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). Data are represented as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mean±SEM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(n=5 for vehicle (saline) and n=5 for LPS)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262632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E0314114-2A0D-4455-B0DB-CDEA9006A593}"/>
              </a:ext>
            </a:extLst>
          </p:cNvPr>
          <p:cNvSpPr/>
          <p:nvPr/>
        </p:nvSpPr>
        <p:spPr>
          <a:xfrm>
            <a:off x="1159449" y="6748334"/>
            <a:ext cx="5982411" cy="7737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2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uantification of IL-1</a:t>
            </a:r>
            <a:r>
              <a:rPr lang="el-GR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RNA in H9c2 cells after FTO knockdown or Scrambled (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r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-siRNA transfection followed by LPS stimulation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xmlns="" id="{44880188-BFB8-4ABF-912E-271BD850C3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0392906"/>
              </p:ext>
            </p:extLst>
          </p:nvPr>
        </p:nvGraphicFramePr>
        <p:xfrm>
          <a:off x="1939752" y="2656840"/>
          <a:ext cx="3533585" cy="39011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57" name="Prism 9" r:id="rId3" imgW="2686339" imgH="2965364" progId="Prism9.Document">
                  <p:embed/>
                </p:oleObj>
              </mc:Choice>
              <mc:Fallback>
                <p:oleObj name="Prism 9" r:id="rId3" imgW="2686339" imgH="296536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39752" y="2656840"/>
                        <a:ext cx="3533585" cy="39011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967B9AFB-E6AC-E540-8837-20F1159D48FE}"/>
              </a:ext>
            </a:extLst>
          </p:cNvPr>
          <p:cNvSpPr txBox="1"/>
          <p:nvPr/>
        </p:nvSpPr>
        <p:spPr>
          <a:xfrm>
            <a:off x="3135902" y="1778000"/>
            <a:ext cx="2029506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360" b="1" dirty="0"/>
              <a:t>Supplementary Fig. S2</a:t>
            </a:r>
            <a:endParaRPr lang="en-US" sz="1360" dirty="0"/>
          </a:p>
        </p:txBody>
      </p:sp>
    </p:spTree>
    <p:extLst>
      <p:ext uri="{BB962C8B-B14F-4D97-AF65-F5344CB8AC3E}">
        <p14:creationId xmlns:p14="http://schemas.microsoft.com/office/powerpoint/2010/main" val="30382075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xmlns="" id="{F6F2BDFB-B079-4EBA-B88E-20EF7A3847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2318640"/>
              </p:ext>
            </p:extLst>
          </p:nvPr>
        </p:nvGraphicFramePr>
        <p:xfrm>
          <a:off x="2110635" y="2389718"/>
          <a:ext cx="3578542" cy="37008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1" name="Prism 9" r:id="rId3" imgW="2674460" imgH="2762705" progId="Prism9.Document">
                  <p:embed/>
                </p:oleObj>
              </mc:Choice>
              <mc:Fallback>
                <p:oleObj name="Prism 9" r:id="rId3" imgW="2674460" imgH="2762705" progId="Prism9.Document">
                  <p:embed/>
                  <p:pic>
                    <p:nvPicPr>
                      <p:cNvPr id="15" name="Object 1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10635" y="2389718"/>
                        <a:ext cx="3578542" cy="3700886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44F50D26-2AD1-4CB9-8663-8BB7E75B7FCC}"/>
              </a:ext>
            </a:extLst>
          </p:cNvPr>
          <p:cNvSpPr txBox="1"/>
          <p:nvPr/>
        </p:nvSpPr>
        <p:spPr>
          <a:xfrm>
            <a:off x="2922625" y="1543152"/>
            <a:ext cx="2208175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360" b="1" dirty="0"/>
              <a:t>Supplementary Fig. S3 </a:t>
            </a:r>
            <a:endParaRPr lang="en-US" sz="1360" dirty="0">
              <a:solidFill>
                <a:srgbClr val="FF0000"/>
              </a:solidFill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24FEEA28-C6FC-B34F-82DF-00E5B8879E0E}"/>
              </a:ext>
            </a:extLst>
          </p:cNvPr>
          <p:cNvSpPr/>
          <p:nvPr/>
        </p:nvSpPr>
        <p:spPr>
          <a:xfrm>
            <a:off x="749729" y="6635549"/>
            <a:ext cx="6332995" cy="15123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3.  FTO knockdown does not affect proliferation of H9c2 cells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9c2 cells were transfected with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r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ontrol or FTO siRNA, and cell proliferation was measured using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yQUANT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ell proliferation assay (data represented ± SEM, n=8). Ns, not significant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15134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13153B6D-D07F-324A-A6EF-C9E0DE0FDA88}"/>
              </a:ext>
            </a:extLst>
          </p:cNvPr>
          <p:cNvSpPr txBox="1"/>
          <p:nvPr/>
        </p:nvSpPr>
        <p:spPr>
          <a:xfrm>
            <a:off x="3046980" y="755300"/>
            <a:ext cx="1978646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360" b="1" dirty="0"/>
              <a:t>Supplementary Fig. S4</a:t>
            </a:r>
            <a:endParaRPr lang="en-US" sz="1360" dirty="0">
              <a:solidFill>
                <a:srgbClr val="FF0000"/>
              </a:solidFill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6994259"/>
              </p:ext>
            </p:extLst>
          </p:nvPr>
        </p:nvGraphicFramePr>
        <p:xfrm>
          <a:off x="910907" y="4041932"/>
          <a:ext cx="3001010" cy="34490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85" name="Prism 9" r:id="rId3" imgW="2648544" imgH="3043116" progId="Prism9.Document">
                  <p:embed/>
                </p:oleObj>
              </mc:Choice>
              <mc:Fallback>
                <p:oleObj name="Prism 9" r:id="rId3" imgW="2648544" imgH="304311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10907" y="4041932"/>
                        <a:ext cx="3001010" cy="34490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847FAD7-FE40-4A86-B550-A0C8521DED18}"/>
              </a:ext>
            </a:extLst>
          </p:cNvPr>
          <p:cNvSpPr txBox="1"/>
          <p:nvPr/>
        </p:nvSpPr>
        <p:spPr>
          <a:xfrm>
            <a:off x="910907" y="4147471"/>
            <a:ext cx="232246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18C353F8-3311-8545-928E-C74FC6826EBE}"/>
              </a:ext>
            </a:extLst>
          </p:cNvPr>
          <p:cNvSpPr/>
          <p:nvPr/>
        </p:nvSpPr>
        <p:spPr>
          <a:xfrm>
            <a:off x="693919" y="7615061"/>
            <a:ext cx="5982411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4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uantification of proinflammatory cytokine mRNA in input RNA isolated from scramble and Si-FTO knockdown cells used for </a:t>
            </a:r>
            <a:r>
              <a:rPr lang="en-US" sz="1200" b="1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RIP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. Total RNA yield in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RIP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ssay in IgG, m6A untreated and m6A LPS stimulated cells. B &amp; C. mRNA expression in of IL6 and TNFα in input RNA used for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RIP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ssay in Figure7.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US" sz="1200" dirty="0">
              <a:solidFill>
                <a:srgbClr val="FF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xmlns="" id="{86EBCCCE-4F52-48D8-B9B2-1E390EBEAC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8173296"/>
              </p:ext>
            </p:extLst>
          </p:nvPr>
        </p:nvGraphicFramePr>
        <p:xfrm>
          <a:off x="2895159" y="1356386"/>
          <a:ext cx="2332038" cy="2665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86" name="Prism 9" r:id="rId5" imgW="2331424" imgH="2665156" progId="Prism9.Document">
                  <p:embed/>
                </p:oleObj>
              </mc:Choice>
              <mc:Fallback>
                <p:oleObj name="Prism 9" r:id="rId5" imgW="2331424" imgH="2665156" progId="Prism9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xmlns="" id="{82A824E2-A740-4B81-9CAC-FEE763E31E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95159" y="1356386"/>
                        <a:ext cx="2332038" cy="2665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1F018ACA-EC50-4E49-9C69-C317E62314A6}"/>
              </a:ext>
            </a:extLst>
          </p:cNvPr>
          <p:cNvSpPr txBox="1"/>
          <p:nvPr/>
        </p:nvSpPr>
        <p:spPr>
          <a:xfrm>
            <a:off x="4267875" y="5119012"/>
            <a:ext cx="355949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xmlns="" id="{655342A2-F1DF-4DA3-A828-A6BAC25B02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0544337"/>
              </p:ext>
            </p:extLst>
          </p:nvPr>
        </p:nvGraphicFramePr>
        <p:xfrm>
          <a:off x="3720751" y="4041933"/>
          <a:ext cx="3166533" cy="35731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87" name="Prism 9" r:id="rId7" imgW="2793245" imgH="3152904" progId="Prism9.Document">
                  <p:embed/>
                </p:oleObj>
              </mc:Choice>
              <mc:Fallback>
                <p:oleObj name="Prism 9" r:id="rId7" imgW="2793245" imgH="3152904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720751" y="4041933"/>
                        <a:ext cx="3166533" cy="35731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18D40D0B-95F0-40EF-BF9D-E4BD8E7B2CD4}"/>
              </a:ext>
            </a:extLst>
          </p:cNvPr>
          <p:cNvSpPr txBox="1"/>
          <p:nvPr/>
        </p:nvSpPr>
        <p:spPr>
          <a:xfrm>
            <a:off x="4061178" y="4147879"/>
            <a:ext cx="355949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F3549A55-41BA-41E7-8177-0A4FD9EFDD65}"/>
              </a:ext>
            </a:extLst>
          </p:cNvPr>
          <p:cNvSpPr txBox="1"/>
          <p:nvPr/>
        </p:nvSpPr>
        <p:spPr>
          <a:xfrm>
            <a:off x="2539210" y="1432713"/>
            <a:ext cx="355949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792500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90</TotalTime>
  <Words>272</Words>
  <Application>Microsoft Office PowerPoint</Application>
  <PresentationFormat>Custom</PresentationFormat>
  <Paragraphs>50</Paragraphs>
  <Slides>5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aveen Kumar Dubey</dc:creator>
  <cp:lastModifiedBy>Prema K.</cp:lastModifiedBy>
  <cp:revision>698</cp:revision>
  <cp:lastPrinted>2021-06-29T20:26:28Z</cp:lastPrinted>
  <dcterms:created xsi:type="dcterms:W3CDTF">2021-01-18T02:22:39Z</dcterms:created>
  <dcterms:modified xsi:type="dcterms:W3CDTF">2021-09-21T01:00:58Z</dcterms:modified>
</cp:coreProperties>
</file>